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0" d="100"/>
          <a:sy n="100" d="100"/>
        </p:scale>
        <p:origin x="1836" y="90"/>
      </p:cViewPr>
      <p:guideLst>
        <p:guide orient="horz" pos="2160"/>
        <p:guide pos="288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23/10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3/10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3/10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3/10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3/10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3/10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3/10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3/10/2019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3/10/2019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3/10/2019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3/10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3/10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23/10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JPG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361344" y="6215457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674603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Akbar et al (2019) Diabetologia DOI 10.1007/s00125-019-05014-5 </a:t>
            </a:r>
          </a:p>
          <a:p>
            <a:r>
              <a:rPr lang="en-GB" sz="1200" dirty="0"/>
              <a:t>©The Authors 2019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33841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The EV landscape at a glance from biogenesis to isolation and characterisation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10D8A11-A017-4C31-B43F-A526FFF8BD17}"/>
              </a:ext>
            </a:extLst>
          </p:cNvPr>
          <p:cNvSpPr txBox="1"/>
          <p:nvPr/>
        </p:nvSpPr>
        <p:spPr>
          <a:xfrm>
            <a:off x="3582189" y="379451"/>
            <a:ext cx="2702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Picture 9" descr="A close up of a logo&#10;&#10;Description automatically generated">
            <a:extLst>
              <a:ext uri="{FF2B5EF4-FFF2-40B4-BE49-F238E27FC236}">
                <a16:creationId xmlns:a16="http://schemas.microsoft.com/office/drawing/2014/main" id="{58BCC52D-E0B8-4E79-B956-97D3D1BAFF3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1072" y="438391"/>
            <a:ext cx="7801855" cy="54433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5</TotalTime>
  <Words>54</Words>
  <Application>Microsoft Office PowerPoint</Application>
  <PresentationFormat>On-screen Show (4:3)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Jose Ruffino</cp:lastModifiedBy>
  <cp:revision>34</cp:revision>
  <dcterms:created xsi:type="dcterms:W3CDTF">2016-06-15T12:53:43Z</dcterms:created>
  <dcterms:modified xsi:type="dcterms:W3CDTF">2019-10-23T17:02:32Z</dcterms:modified>
</cp:coreProperties>
</file>